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14630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918" y="-72"/>
      </p:cViewPr>
      <p:guideLst>
        <p:guide orient="horz" pos="4608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4544908"/>
            <a:ext cx="7772400" cy="313605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8290560"/>
            <a:ext cx="6400800" cy="37388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249681"/>
            <a:ext cx="2057400" cy="2663274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249681"/>
            <a:ext cx="6019800" cy="2663274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9401388"/>
            <a:ext cx="7772400" cy="290576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6200989"/>
            <a:ext cx="7772400" cy="32003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7281335"/>
            <a:ext cx="4038600" cy="206010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7281335"/>
            <a:ext cx="4038600" cy="206010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85894"/>
            <a:ext cx="8229600" cy="2438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3274908"/>
            <a:ext cx="4040188" cy="136482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4639734"/>
            <a:ext cx="4040188" cy="84294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3274908"/>
            <a:ext cx="4041775" cy="136482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4639734"/>
            <a:ext cx="4041775" cy="84294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582507"/>
            <a:ext cx="3008313" cy="24790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582508"/>
            <a:ext cx="5111750" cy="1248664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3061548"/>
            <a:ext cx="3008313" cy="100076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10241280"/>
            <a:ext cx="5486400" cy="120904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1307253"/>
            <a:ext cx="5486400" cy="87782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11450321"/>
            <a:ext cx="5486400" cy="171703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85894"/>
            <a:ext cx="8229600" cy="2438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3413761"/>
            <a:ext cx="8229600" cy="96553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3560215"/>
            <a:ext cx="213360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5D0D1-B7DB-4D8A-A9C4-3B109C1C6BD1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13560215"/>
            <a:ext cx="289560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13560215"/>
            <a:ext cx="213360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0F730E-9611-44AA-AE01-E90D8B937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>
            <a:grpSpLocks noChangeAspect="1"/>
          </p:cNvGrpSpPr>
          <p:nvPr/>
        </p:nvGrpSpPr>
        <p:grpSpPr>
          <a:xfrm>
            <a:off x="76200" y="0"/>
            <a:ext cx="8915400" cy="13925729"/>
            <a:chOff x="76200" y="0"/>
            <a:chExt cx="8915400" cy="13925729"/>
          </a:xfrm>
        </p:grpSpPr>
        <p:grpSp>
          <p:nvGrpSpPr>
            <p:cNvPr id="25" name="Group 24"/>
            <p:cNvGrpSpPr/>
            <p:nvPr/>
          </p:nvGrpSpPr>
          <p:grpSpPr>
            <a:xfrm>
              <a:off x="407035" y="0"/>
              <a:ext cx="8391525" cy="12134849"/>
              <a:chOff x="407035" y="0"/>
              <a:chExt cx="8391525" cy="12134849"/>
            </a:xfrm>
          </p:grpSpPr>
          <p:grpSp>
            <p:nvGrpSpPr>
              <p:cNvPr id="4" name="Group 4"/>
              <p:cNvGrpSpPr>
                <a:grpSpLocks/>
              </p:cNvGrpSpPr>
              <p:nvPr/>
            </p:nvGrpSpPr>
            <p:grpSpPr bwMode="auto">
              <a:xfrm>
                <a:off x="419100" y="0"/>
                <a:ext cx="8343900" cy="5976937"/>
                <a:chOff x="304800" y="76200"/>
                <a:chExt cx="8344299" cy="5977187"/>
              </a:xfrm>
            </p:grpSpPr>
            <p:pic>
              <p:nvPicPr>
                <p:cNvPr id="5" name="Picture 2" descr="C:\Users\yash\AppData\Local\Temp\copypicture.png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304801" y="457200"/>
                  <a:ext cx="4074986" cy="2546866"/>
                </a:xfrm>
                <a:prstGeom prst="rect">
                  <a:avLst/>
                </a:prstGeom>
                <a:noFill/>
                <a:ln w="9525">
                  <a:solidFill>
                    <a:schemeClr val="accent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6" name="Picture 3" descr="C:\Users\yash\AppData\Local\Temp\copypicture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4568390" y="457201"/>
                  <a:ext cx="4077098" cy="2548186"/>
                </a:xfrm>
                <a:prstGeom prst="rect">
                  <a:avLst/>
                </a:prstGeom>
                <a:noFill/>
                <a:ln w="9525">
                  <a:solidFill>
                    <a:schemeClr val="accent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7" name="Picture 4" descr="C:\Users\yash\AppData\Local\Temp\copypicture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/>
                <a:stretch>
                  <a:fillRect/>
                </a:stretch>
              </p:blipFill>
              <p:spPr bwMode="auto">
                <a:xfrm>
                  <a:off x="304800" y="3505200"/>
                  <a:ext cx="4077099" cy="2548187"/>
                </a:xfrm>
                <a:prstGeom prst="rect">
                  <a:avLst/>
                </a:prstGeom>
                <a:noFill/>
                <a:ln w="9525">
                  <a:solidFill>
                    <a:schemeClr val="accent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8" name="Picture 5" descr="C:\Users\yash\AppData\Local\Temp\copypicture.png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4572000" y="3505200"/>
                  <a:ext cx="4077099" cy="2548187"/>
                </a:xfrm>
                <a:prstGeom prst="rect">
                  <a:avLst/>
                </a:prstGeom>
                <a:noFill/>
                <a:ln w="9525">
                  <a:solidFill>
                    <a:schemeClr val="accent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9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2007014" y="76200"/>
                  <a:ext cx="336336" cy="2770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a</a:t>
                  </a:r>
                  <a:endParaRPr lang="en-US" sz="1200" b="1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0" name="TextBox 10"/>
                <p:cNvSpPr txBox="1">
                  <a:spLocks noChangeArrowheads="1"/>
                </p:cNvSpPr>
                <p:nvPr/>
              </p:nvSpPr>
              <p:spPr bwMode="auto">
                <a:xfrm>
                  <a:off x="6370320" y="76200"/>
                  <a:ext cx="411480" cy="2770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b</a:t>
                  </a:r>
                  <a:endParaRPr lang="en-US" sz="1200" b="1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1" name="TextBox 11"/>
                <p:cNvSpPr txBox="1">
                  <a:spLocks noChangeArrowheads="1"/>
                </p:cNvSpPr>
                <p:nvPr/>
              </p:nvSpPr>
              <p:spPr bwMode="auto">
                <a:xfrm>
                  <a:off x="1950720" y="3124200"/>
                  <a:ext cx="411480" cy="2770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c</a:t>
                  </a:r>
                  <a:endParaRPr lang="en-US" sz="1200" b="1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2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6370320" y="3124200"/>
                  <a:ext cx="411480" cy="2770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d</a:t>
                  </a:r>
                  <a:endParaRPr lang="en-US" sz="1200" b="1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grpSp>
            <p:nvGrpSpPr>
              <p:cNvPr id="24" name="Group 23"/>
              <p:cNvGrpSpPr/>
              <p:nvPr/>
            </p:nvGrpSpPr>
            <p:grpSpPr>
              <a:xfrm>
                <a:off x="407035" y="6096000"/>
                <a:ext cx="8391525" cy="6038849"/>
                <a:chOff x="407035" y="6096000"/>
                <a:chExt cx="8391525" cy="6038849"/>
              </a:xfrm>
            </p:grpSpPr>
            <p:pic>
              <p:nvPicPr>
                <p:cNvPr id="14" name="Picture 3" descr="C:\Users\yash\AppData\Local\Temp\copypicture.png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4711697" y="6510288"/>
                  <a:ext cx="4077428" cy="2547861"/>
                </a:xfrm>
                <a:prstGeom prst="rect">
                  <a:avLst/>
                </a:prstGeom>
                <a:noFill/>
                <a:ln w="9525">
                  <a:solidFill>
                    <a:schemeClr val="accent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15" name="Picture 5" descr="C:\Users\yash\AppData\Local\Temp\copypicture.png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407035" y="9557898"/>
                  <a:ext cx="4123981" cy="2576951"/>
                </a:xfrm>
                <a:prstGeom prst="rect">
                  <a:avLst/>
                </a:prstGeom>
                <a:noFill/>
                <a:ln w="9525">
                  <a:solidFill>
                    <a:schemeClr val="accent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16" name="Picture 6" descr="C:\Users\yash\AppData\Local\Temp\copypicture.png"/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4732593" y="9557898"/>
                  <a:ext cx="4065967" cy="2540699"/>
                </a:xfrm>
                <a:prstGeom prst="rect">
                  <a:avLst/>
                </a:prstGeom>
                <a:noFill/>
                <a:ln w="9525">
                  <a:solidFill>
                    <a:schemeClr val="accent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17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2057400" y="6096000"/>
                  <a:ext cx="446550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e</a:t>
                  </a:r>
                  <a:endParaRPr lang="en-US" sz="1200" b="1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8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6493523" y="6129337"/>
                  <a:ext cx="411513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f</a:t>
                  </a:r>
                  <a:endParaRPr lang="en-US" sz="1200" b="1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9" name="TextBox 19"/>
                <p:cNvSpPr txBox="1">
                  <a:spLocks noChangeArrowheads="1"/>
                </p:cNvSpPr>
                <p:nvPr/>
              </p:nvSpPr>
              <p:spPr bwMode="auto">
                <a:xfrm>
                  <a:off x="2057400" y="9112423"/>
                  <a:ext cx="411513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g</a:t>
                  </a:r>
                  <a:endParaRPr lang="en-US" sz="1200" b="1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20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6493523" y="9112423"/>
                  <a:ext cx="411513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h</a:t>
                  </a:r>
                  <a:endParaRPr lang="en-US" sz="1200" b="1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  <p:pic>
              <p:nvPicPr>
                <p:cNvPr id="21" name="Picture 4" descr="C:\Users\yash\AppData\Local\Temp\copypicture.png"/>
                <p:cNvPicPr>
                  <a:picLocks noChangeAspect="1" noChangeArrowheads="1"/>
                </p:cNvPicPr>
                <p:nvPr/>
              </p:nvPicPr>
              <p:blipFill>
                <a:blip r:embed="rId9" cstate="print"/>
                <a:srcRect/>
                <a:stretch>
                  <a:fillRect/>
                </a:stretch>
              </p:blipFill>
              <p:spPr bwMode="auto">
                <a:xfrm>
                  <a:off x="453588" y="6510288"/>
                  <a:ext cx="4077428" cy="2547861"/>
                </a:xfrm>
                <a:prstGeom prst="rect">
                  <a:avLst/>
                </a:prstGeom>
                <a:noFill/>
                <a:ln w="9525">
                  <a:solidFill>
                    <a:schemeClr val="accent1"/>
                  </a:solidFill>
                  <a:miter lim="800000"/>
                  <a:headEnd/>
                  <a:tailEnd/>
                </a:ln>
              </p:spPr>
            </p:pic>
          </p:grpSp>
        </p:grpSp>
        <p:sp>
          <p:nvSpPr>
            <p:cNvPr id="22" name="Rectangle 21"/>
            <p:cNvSpPr/>
            <p:nvPr/>
          </p:nvSpPr>
          <p:spPr>
            <a:xfrm>
              <a:off x="76200" y="12725400"/>
              <a:ext cx="8915400" cy="12003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 smtClean="0">
                  <a:latin typeface="Helvetica" pitchFamily="34" charset="0"/>
                  <a:cs typeface="Helvetica" pitchFamily="34" charset="0"/>
                </a:rPr>
                <a:t>Figure </a:t>
              </a:r>
              <a:r>
                <a:rPr lang="en-US" sz="1200" b="1" dirty="0" smtClean="0">
                  <a:latin typeface="Helvetica" pitchFamily="34" charset="0"/>
                  <a:cs typeface="Helvetica" pitchFamily="34" charset="0"/>
                </a:rPr>
                <a:t>S2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Permutation test results for OPLS-DA models with two components and 200 permutations. Models of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(a-d)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resistant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(DV) chickpea plants are shown at 2, 4, 8 and 12 DAI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and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(</a:t>
              </a:r>
              <a:r>
                <a:rPr lang="en-US" sz="1200" i="1" dirty="0" smtClean="0">
                  <a:latin typeface="Helvetica" pitchFamily="34" charset="0"/>
                  <a:cs typeface="Helvetica" pitchFamily="34" charset="0"/>
                </a:rPr>
                <a:t>e-h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)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susceptible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(JG62) of same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stages. a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DVC2 vs. DVI2 (intercepts: R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0.626; Q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-0.196);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b</a:t>
              </a:r>
              <a:r>
                <a:rPr lang="en-US" sz="1200" i="1" dirty="0" smtClean="0">
                  <a:latin typeface="Helvetica" pitchFamily="34" charset="0"/>
                  <a:cs typeface="Helvetica" pitchFamily="34" charset="0"/>
                </a:rPr>
                <a:t>: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DVC4 vs. DVI4 (intercepts: R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0.742; Q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-0.254);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c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DVC8 vs. DVI8 (intercepts: R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0.694; Q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-0.0844);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d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DVC12 vs. DVI12 (intercepts: R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0.683; Q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-0.0642);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e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JGC2 vs. JGI2 (intercepts: R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0.63, Q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-0.199);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f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JGC4 vs. JGI4 (intercepts: R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0.6; Q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-0.0601);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g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JGC8 vs. JGI8 (intercepts: R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0.651, Q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-0.132) and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h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JGC12 vs. JGI12 (intercepts: R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0.574, Q</a:t>
              </a:r>
              <a:r>
                <a:rPr lang="en-US" sz="1200" baseline="30000" dirty="0">
                  <a:latin typeface="Helvetica" pitchFamily="34" charset="0"/>
                  <a:cs typeface="Helvetica" pitchFamily="34" charset="0"/>
                </a:rPr>
                <a:t>2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=0.0, -0.0575).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03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ashwant Kumar</dc:creator>
  <cp:lastModifiedBy>Bhushan</cp:lastModifiedBy>
  <cp:revision>6</cp:revision>
  <dcterms:created xsi:type="dcterms:W3CDTF">2014-05-21T12:58:07Z</dcterms:created>
  <dcterms:modified xsi:type="dcterms:W3CDTF">2015-09-22T14:54:49Z</dcterms:modified>
</cp:coreProperties>
</file>